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7" r:id="rId2"/>
    <p:sldId id="258" r:id="rId3"/>
    <p:sldId id="259" r:id="rId4"/>
    <p:sldId id="260" r:id="rId5"/>
    <p:sldId id="261" r:id="rId6"/>
    <p:sldId id="263" r:id="rId7"/>
    <p:sldId id="264" r:id="rId8"/>
    <p:sldId id="265" r:id="rId9"/>
    <p:sldId id="262" r:id="rId10"/>
    <p:sldId id="266" r:id="rId11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8" autoAdjust="0"/>
    <p:restoredTop sz="94660"/>
  </p:normalViewPr>
  <p:slideViewPr>
    <p:cSldViewPr>
      <p:cViewPr varScale="1">
        <p:scale>
          <a:sx n="72" d="100"/>
          <a:sy n="72" d="100"/>
        </p:scale>
        <p:origin x="132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D6C9BCD-75F2-4030-9BF9-D93B99EC6B46}" type="datetimeFigureOut">
              <a:rPr lang="es-ES" smtClean="0"/>
              <a:pPr/>
              <a:t>30/10/2017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BEBA2D-8AB6-4C41-B152-1C5B001823B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AA7AAB-8E81-4061-9648-36480B332F34}" type="slidenum">
              <a:rPr lang="es-ES" smtClean="0"/>
              <a:pPr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22778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16FB-E38C-49F0-AD0B-E567667508DF}" type="datetimeFigureOut">
              <a:rPr lang="es-ES" smtClean="0"/>
              <a:pPr/>
              <a:t>30/10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6C00F-1730-4753-B0DC-F3F4A2658BE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16FB-E38C-49F0-AD0B-E567667508DF}" type="datetimeFigureOut">
              <a:rPr lang="es-ES" smtClean="0"/>
              <a:pPr/>
              <a:t>30/10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6C00F-1730-4753-B0DC-F3F4A2658BE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16FB-E38C-49F0-AD0B-E567667508DF}" type="datetimeFigureOut">
              <a:rPr lang="es-ES" smtClean="0"/>
              <a:pPr/>
              <a:t>30/10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6C00F-1730-4753-B0DC-F3F4A2658BE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16FB-E38C-49F0-AD0B-E567667508DF}" type="datetimeFigureOut">
              <a:rPr lang="es-ES" smtClean="0"/>
              <a:pPr/>
              <a:t>30/10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6C00F-1730-4753-B0DC-F3F4A2658BE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16FB-E38C-49F0-AD0B-E567667508DF}" type="datetimeFigureOut">
              <a:rPr lang="es-ES" smtClean="0"/>
              <a:pPr/>
              <a:t>30/10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6C00F-1730-4753-B0DC-F3F4A2658BE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16FB-E38C-49F0-AD0B-E567667508DF}" type="datetimeFigureOut">
              <a:rPr lang="es-ES" smtClean="0"/>
              <a:pPr/>
              <a:t>30/10/20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6C00F-1730-4753-B0DC-F3F4A2658BE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16FB-E38C-49F0-AD0B-E567667508DF}" type="datetimeFigureOut">
              <a:rPr lang="es-ES" smtClean="0"/>
              <a:pPr/>
              <a:t>30/10/2017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6C00F-1730-4753-B0DC-F3F4A2658BE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16FB-E38C-49F0-AD0B-E567667508DF}" type="datetimeFigureOut">
              <a:rPr lang="es-ES" smtClean="0"/>
              <a:pPr/>
              <a:t>30/10/2017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6C00F-1730-4753-B0DC-F3F4A2658BE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16FB-E38C-49F0-AD0B-E567667508DF}" type="datetimeFigureOut">
              <a:rPr lang="es-ES" smtClean="0"/>
              <a:pPr/>
              <a:t>30/10/2017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6C00F-1730-4753-B0DC-F3F4A2658BE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16FB-E38C-49F0-AD0B-E567667508DF}" type="datetimeFigureOut">
              <a:rPr lang="es-ES" smtClean="0"/>
              <a:pPr/>
              <a:t>30/10/20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6C00F-1730-4753-B0DC-F3F4A2658BE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16FB-E38C-49F0-AD0B-E567667508DF}" type="datetimeFigureOut">
              <a:rPr lang="es-ES" smtClean="0"/>
              <a:pPr/>
              <a:t>30/10/20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6C00F-1730-4753-B0DC-F3F4A2658BE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1D16FB-E38C-49F0-AD0B-E567667508DF}" type="datetimeFigureOut">
              <a:rPr lang="es-ES" smtClean="0"/>
              <a:pPr/>
              <a:t>30/10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B6C00F-1730-4753-B0DC-F3F4A2658BE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5 Rectángulo"/>
          <p:cNvSpPr/>
          <p:nvPr/>
        </p:nvSpPr>
        <p:spPr>
          <a:xfrm>
            <a:off x="395537" y="476672"/>
            <a:ext cx="8424935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Times New Roman" pitchFamily="18" charset="0"/>
                <a:cs typeface="Times New Roman" pitchFamily="18" charset="0"/>
              </a:rPr>
              <a:t>Supplementary Table S1. </a:t>
            </a:r>
            <a:r>
              <a:rPr lang="en-GB" sz="10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n-GB" sz="1000" dirty="0">
                <a:latin typeface="Times New Roman" pitchFamily="18" charset="0"/>
                <a:cs typeface="Times New Roman" pitchFamily="18" charset="0"/>
              </a:rPr>
              <a:t> Data.  Reference of genes studied in this work and RT-</a:t>
            </a:r>
            <a:r>
              <a:rPr lang="en-GB" sz="10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n-GB" sz="1000" dirty="0">
                <a:latin typeface="Times New Roman" pitchFamily="18" charset="0"/>
                <a:cs typeface="Times New Roman" pitchFamily="18" charset="0"/>
              </a:rPr>
              <a:t> data for the standard curve. Table shows the name of the gene;   Sequences of primers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(5’ </a:t>
            </a:r>
            <a:r>
              <a:rPr lang="en-US" sz="1000" dirty="0">
                <a:latin typeface="Times New Roman" pitchFamily="18" charset="0"/>
                <a:cs typeface="Times New Roman" pitchFamily="18" charset="0"/>
                <a:sym typeface="Wingdings"/>
              </a:rPr>
              <a:t>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3’); Efficiency, Slope and R</a:t>
            </a:r>
            <a:r>
              <a:rPr lang="en-US" sz="1000" baseline="30000" dirty="0">
                <a:latin typeface="Times New Roman" pitchFamily="18" charset="0"/>
                <a:cs typeface="Times New Roman" pitchFamily="18" charset="0"/>
              </a:rPr>
              <a:t>2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for the corresponding linear regression to normalize the data, using BcEF1b as endogenous gene. </a:t>
            </a:r>
            <a:endParaRPr lang="en-GB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6 CuadroTexto"/>
          <p:cNvSpPr txBox="1"/>
          <p:nvPr/>
        </p:nvSpPr>
        <p:spPr>
          <a:xfrm>
            <a:off x="1547664" y="306896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ES" dirty="0"/>
          </a:p>
        </p:txBody>
      </p:sp>
      <p:graphicFrame>
        <p:nvGraphicFramePr>
          <p:cNvPr id="9" name="8 Tabla"/>
          <p:cNvGraphicFramePr>
            <a:graphicFrameLocks noGrp="1"/>
          </p:cNvGraphicFramePr>
          <p:nvPr/>
        </p:nvGraphicFramePr>
        <p:xfrm>
          <a:off x="755576" y="1196752"/>
          <a:ext cx="7848872" cy="1008111"/>
        </p:xfrm>
        <a:graphic>
          <a:graphicData uri="http://schemas.openxmlformats.org/drawingml/2006/table">
            <a:tbl>
              <a:tblPr firstRow="1">
                <a:tableStyleId>{6E25E649-3F16-4E02-A733-19D2CDBF48F0}</a:tableStyleId>
              </a:tblPr>
              <a:tblGrid>
                <a:gridCol w="86409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9189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3016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4900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0945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3603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 pitchFamily="18" charset="0"/>
                          <a:cs typeface="Times New Roman" pitchFamily="18" charset="0"/>
                        </a:rPr>
                        <a:t>Gene</a:t>
                      </a:r>
                      <a:endParaRPr lang="es-ES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 pitchFamily="18" charset="0"/>
                          <a:cs typeface="Times New Roman" pitchFamily="18" charset="0"/>
                        </a:rPr>
                        <a:t>Primer Forward </a:t>
                      </a:r>
                      <a:endParaRPr lang="es-ES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 pitchFamily="18" charset="0"/>
                          <a:cs typeface="Times New Roman" pitchFamily="18" charset="0"/>
                        </a:rPr>
                        <a:t>Primer Reverse </a:t>
                      </a:r>
                      <a:endParaRPr lang="es-ES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 pitchFamily="18" charset="0"/>
                          <a:cs typeface="Times New Roman" pitchFamily="18" charset="0"/>
                        </a:rPr>
                        <a:t>Eficiency (%)</a:t>
                      </a:r>
                      <a:endParaRPr lang="es-ES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 pitchFamily="18" charset="0"/>
                          <a:cs typeface="Times New Roman" pitchFamily="18" charset="0"/>
                        </a:rPr>
                        <a:t>Slope</a:t>
                      </a:r>
                      <a:endParaRPr lang="es-ES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 pitchFamily="18" charset="0"/>
                          <a:cs typeface="Times New Roman" pitchFamily="18" charset="0"/>
                        </a:rPr>
                        <a:t>R</a:t>
                      </a:r>
                      <a:r>
                        <a:rPr lang="en-US" sz="1000" baseline="30000"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endParaRPr lang="es-ES" sz="10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3603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Times New Roman" pitchFamily="18" charset="0"/>
                          <a:cs typeface="Times New Roman" pitchFamily="18" charset="0"/>
                        </a:rPr>
                        <a:t>BcBot2</a:t>
                      </a:r>
                      <a:endParaRPr lang="es-ES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u="none" strike="noStrike" cap="none" normalizeH="0" baseline="0" dirty="0">
                          <a:ln>
                            <a:noFill/>
                          </a:ln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AGGTTATCCCTTTGCATGAGTAGT</a:t>
                      </a: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u="none" strike="noStrike" cap="none" normalizeH="0" baseline="0" dirty="0">
                          <a:ln>
                            <a:noFill/>
                          </a:ln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CCACAGGGTGAATGATGTTTTGTCTT</a:t>
                      </a: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Times New Roman" pitchFamily="18" charset="0"/>
                          <a:cs typeface="Times New Roman" pitchFamily="18" charset="0"/>
                        </a:rPr>
                        <a:t>109,03</a:t>
                      </a:r>
                      <a:endParaRPr lang="es-ES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Times New Roman" pitchFamily="18" charset="0"/>
                          <a:cs typeface="Times New Roman" pitchFamily="18" charset="0"/>
                        </a:rPr>
                        <a:t>-3.12296</a:t>
                      </a:r>
                      <a:endParaRPr lang="es-ES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Times New Roman" pitchFamily="18" charset="0"/>
                          <a:cs typeface="Times New Roman" pitchFamily="18" charset="0"/>
                        </a:rPr>
                        <a:t>0.991</a:t>
                      </a:r>
                      <a:endParaRPr lang="es-ES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3603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Times New Roman" pitchFamily="18" charset="0"/>
                          <a:cs typeface="Times New Roman" pitchFamily="18" charset="0"/>
                        </a:rPr>
                        <a:t>BCEF1b</a:t>
                      </a:r>
                      <a:endParaRPr lang="es-ES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u="none" strike="noStrike" cap="none" normalizeH="0" baseline="0" dirty="0">
                          <a:ln>
                            <a:noFill/>
                          </a:ln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CTGCCAAGTCTGTTGTCACA</a:t>
                      </a: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u="none" strike="noStrike" cap="none" normalizeH="0" baseline="0" dirty="0">
                          <a:ln>
                            <a:noFill/>
                          </a:ln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AATGCTACCATGTCGGTCTCA</a:t>
                      </a: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Times New Roman" pitchFamily="18" charset="0"/>
                          <a:cs typeface="Times New Roman" pitchFamily="18" charset="0"/>
                        </a:rPr>
                        <a:t>103,18</a:t>
                      </a:r>
                      <a:endParaRPr lang="es-ES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Times New Roman" pitchFamily="18" charset="0"/>
                          <a:cs typeface="Times New Roman" pitchFamily="18" charset="0"/>
                        </a:rPr>
                        <a:t>-3.248</a:t>
                      </a:r>
                      <a:endParaRPr lang="es-ES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Times New Roman" pitchFamily="18" charset="0"/>
                          <a:cs typeface="Times New Roman" pitchFamily="18" charset="0"/>
                        </a:rPr>
                        <a:t>0.992</a:t>
                      </a:r>
                      <a:endParaRPr lang="es-ES" sz="10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9820" marR="29820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>
            <a:extLst>
              <a:ext uri="{FF2B5EF4-FFF2-40B4-BE49-F238E27FC236}">
                <a16:creationId xmlns:a16="http://schemas.microsoft.com/office/drawing/2014/main" id="{6C83D743-C76C-432E-AE25-530542C5C032}"/>
              </a:ext>
            </a:extLst>
          </p:cNvPr>
          <p:cNvSpPr/>
          <p:nvPr/>
        </p:nvSpPr>
        <p:spPr>
          <a:xfrm>
            <a:off x="107504" y="260648"/>
            <a:ext cx="878497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. S8</a:t>
            </a:r>
            <a:r>
              <a:rPr lang="es-E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0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cBOT2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 expression profiles by RT-qPCR.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hows the effects of carbon source on expression levels of the </a:t>
            </a:r>
            <a:r>
              <a:rPr lang="en-GB" sz="10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cBOT2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. Two different carbon sources were used, glucose and de-</a:t>
            </a:r>
            <a:r>
              <a:rPr lang="en-US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teinized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omato cell walls (TCW). Data were normalized using Elongation factor EF1b as endogenous gene. Error-bar in TCW is too small to be visible.</a:t>
            </a:r>
            <a:endParaRPr lang="es-ES" sz="1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2">
            <a:extLst>
              <a:ext uri="{FF2B5EF4-FFF2-40B4-BE49-F238E27FC236}">
                <a16:creationId xmlns:a16="http://schemas.microsoft.com/office/drawing/2014/main" id="{E8FB0B71-3255-4190-9437-6A7A61DC64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339752" y="1268760"/>
            <a:ext cx="4644000" cy="34429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2264343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514" name="Group 154"/>
          <p:cNvGraphicFramePr>
            <a:graphicFrameLocks noGrp="1"/>
          </p:cNvGraphicFramePr>
          <p:nvPr/>
        </p:nvGraphicFramePr>
        <p:xfrm>
          <a:off x="683568" y="1556792"/>
          <a:ext cx="7560839" cy="4113029"/>
        </p:xfrm>
        <a:graphic>
          <a:graphicData uri="http://schemas.openxmlformats.org/drawingml/2006/table">
            <a:tbl>
              <a:tblPr/>
              <a:tblGrid>
                <a:gridCol w="87549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7549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5508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3836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1591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1065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8257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78717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720079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417513">
                <a:tc gridSpan="9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      AVERAGE DIAMETER OF GROWING COLONY (mm)   </a:t>
                      </a: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Times New Roman" pitchFamily="18" charset="0"/>
                      </a:endParaRPr>
                    </a:p>
                  </a:txBody>
                  <a:tcPr marL="44450" marR="4445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8D8D8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333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carbon           source    →</a:t>
                      </a:r>
                    </a:p>
                  </a:txBody>
                  <a:tcPr marL="44450" marR="4445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CMC</a:t>
                      </a:r>
                    </a:p>
                  </a:txBody>
                  <a:tcPr marL="44450" marR="4445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GLU</a:t>
                      </a:r>
                    </a:p>
                  </a:txBody>
                  <a:tcPr marL="44450" marR="4445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TCW</a:t>
                      </a:r>
                    </a:p>
                  </a:txBody>
                  <a:tcPr marL="44450" marR="4445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MALT</a:t>
                      </a:r>
                    </a:p>
                  </a:txBody>
                  <a:tcPr marL="44450" marR="4445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333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days  post-</a:t>
                      </a:r>
                      <a:r>
                        <a:rPr kumimoji="0" lang="es-ES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inoculation</a:t>
                      </a: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 ↓</a:t>
                      </a:r>
                    </a:p>
                  </a:txBody>
                  <a:tcPr marL="44450" marR="4445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12 h Light/Dark</a:t>
                      </a:r>
                    </a:p>
                  </a:txBody>
                  <a:tcPr marL="44450" marR="4445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Continuous</a:t>
                      </a: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kumimoji="0" lang="es-ES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Darkness</a:t>
                      </a: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Times New Roman" pitchFamily="18" charset="0"/>
                      </a:endParaRPr>
                    </a:p>
                  </a:txBody>
                  <a:tcPr marL="44450" marR="4445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12 h Light/Dark</a:t>
                      </a:r>
                    </a:p>
                  </a:txBody>
                  <a:tcPr marL="44450" marR="4445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Continuous</a:t>
                      </a: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kumimoji="0" lang="es-ES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Darkness</a:t>
                      </a: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Times New Roman" pitchFamily="18" charset="0"/>
                      </a:endParaRPr>
                    </a:p>
                  </a:txBody>
                  <a:tcPr marL="44450" marR="4445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12 h Light/Dark</a:t>
                      </a:r>
                    </a:p>
                  </a:txBody>
                  <a:tcPr marL="44450" marR="4445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Continuous</a:t>
                      </a: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kumimoji="0" lang="es-ES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Darkness</a:t>
                      </a: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Times New Roman" pitchFamily="18" charset="0"/>
                      </a:endParaRPr>
                    </a:p>
                  </a:txBody>
                  <a:tcPr marL="44450" marR="4445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12 h Light/Dark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Times New Roman" pitchFamily="18" charset="0"/>
                      </a:endParaRPr>
                    </a:p>
                  </a:txBody>
                  <a:tcPr marL="44450" marR="4445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Continuous</a:t>
                      </a: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kumimoji="0" lang="es-ES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Darkness</a:t>
                      </a: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s-E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Times New Roman" pitchFamily="18" charset="0"/>
                        <a:cs typeface="Times New Roman" pitchFamily="18" charset="0"/>
                      </a:endParaRPr>
                    </a:p>
                  </a:txBody>
                  <a:tcPr marL="44450" marR="4445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7488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.4 ± 0.28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 8.95 ± 0.34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7.9</a:t>
                      </a:r>
                      <a:fld id="{B5E6BFD3-0C2E-4236-89D2-AA3A288397C1}" type="slidenum">
                        <a:rPr kumimoji="0" lang="es-E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pPr marL="0" marR="0" lvl="0" indent="0" algn="r" defTabSz="914400" rtl="0" eaLnBrk="1" fontAlgn="base" latinLnBrk="0" hangingPunct="1">
                          <a:lnSpc>
                            <a:spcPct val="107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t>2</a:t>
                      </a:fld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 ± 0.19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7.6  ± 0.28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.75 ± 0.3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8.6 ± 0.59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.9 ± 0.24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10.3  ± 0.33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7488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10.9 ± 0.19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11.55 ± 0.3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8.95 ± 0.22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8.85 ± 0.43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14.55 ± 0.66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14.65 ± 0.77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19.8 ±  0.41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20.6 ± 0.4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7488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20.15 ± 0.74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20.85 ± 0.41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17.3 ± 0.51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17.15 ± 0.71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30.85 ± 1.37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28.4 ± 1.4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31.3 ±  0.64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32.1 ± 0.75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7488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4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31.2 ± 0.78 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32.1 ± 0.61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31.2 ± 0.78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28.7 ± 0.68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45.4 ± 2.44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48.6 ± 0.4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45.9 ± 0.86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48.6 ± 0.43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7488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44 ± 1.5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44.59 ± 1.12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36.9 ± 1.63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40.15 ± 1.01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61.2 ± 1.86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9.5 ± 1.56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2.35 ± 1.47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8.3 ± 1.22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17488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6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7.05 ± 1.37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6.55 ± 1.14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44.15 ± 1.34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48.85 ± 0.56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78.5 ± 2.96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73.11 ± 1.86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7.15 ± 2.29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66.6 ± 2.07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17488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7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69.75 ±1.37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67.55 ± 1.34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49.1 ± 1.22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3.85 ± 1.17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66.2  ± 2.96  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81.9 ± 3.51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17488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8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81.8 ± 2.27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79.05 ± 2.05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1 ± 1.65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5.7 ± 1.37 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74.5 ± 2.76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17488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2.45 ± 1.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8.5 ± 1.93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84.3 ± 2.05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7488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1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3.1 ± 1.77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8.5 ± 1.93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17488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11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3.7 ± 1.87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8.72 ± 2.03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17488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12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5.1 ± 2.25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59.83 ± 1.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s-E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90</a:t>
                      </a:r>
                    </a:p>
                  </a:txBody>
                  <a:tcPr marL="44450" marR="44450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</a:tbl>
          </a:graphicData>
        </a:graphic>
      </p:graphicFrame>
      <p:sp>
        <p:nvSpPr>
          <p:cNvPr id="83095" name="2 CuadroTexto"/>
          <p:cNvSpPr txBox="1">
            <a:spLocks noChangeArrowheads="1"/>
          </p:cNvSpPr>
          <p:nvPr/>
        </p:nvSpPr>
        <p:spPr bwMode="auto">
          <a:xfrm>
            <a:off x="3995738" y="476250"/>
            <a:ext cx="236537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>
                <a:latin typeface="Calibri" pitchFamily="34" charset="0"/>
              </a:rPr>
              <a:t> </a:t>
            </a:r>
          </a:p>
        </p:txBody>
      </p:sp>
      <p:sp>
        <p:nvSpPr>
          <p:cNvPr id="5" name="4 Rectángulo"/>
          <p:cNvSpPr/>
          <p:nvPr/>
        </p:nvSpPr>
        <p:spPr>
          <a:xfrm>
            <a:off x="323528" y="548680"/>
            <a:ext cx="8424936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Supplementary Table S2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Growth of colony diameter. Average diameter (mm) of growing colony of </a:t>
            </a:r>
            <a:r>
              <a:rPr lang="en-US" sz="1000" i="1" dirty="0">
                <a:latin typeface="Times New Roman" pitchFamily="18" charset="0"/>
                <a:cs typeface="Times New Roman" pitchFamily="18" charset="0"/>
              </a:rPr>
              <a:t>B. cinerea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depending on the available carbon source and on light/dark culture conditions. Four different culture media were used:  Agar  Malt (MA) and MSM plus 1% of a sole carbon source: carboxymethyl cellulose (CMC), de-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proteinized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Tomato cell wall (TCW)  or glucose  (GLU). For each assayed carbon source 10 isolates were cultivated under alternating 12-h light/dark at 22ºC for 12 days, and 10 were wrapped in aluminum foil and cultivated at 22ºC for the same length of time.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395536" y="404664"/>
            <a:ext cx="784887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itchFamily="18" charset="0"/>
              </a:rPr>
              <a:t>Supplementary Fig. S1. </a:t>
            </a:r>
            <a:r>
              <a:rPr lang="en-GB" sz="1000" dirty="0">
                <a:latin typeface="Times New Roman" panose="02020603050405020304" pitchFamily="18" charset="0"/>
                <a:cs typeface="Times New Roman" pitchFamily="18" charset="0"/>
              </a:rPr>
              <a:t>Colony patterning depending on the carbon source (darkness). </a:t>
            </a:r>
            <a:r>
              <a:rPr lang="es-E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.cinerea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100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ny patterning culture at 22ºC in darkness on  A) Minimum Salt Medium (MSM) plus 1% of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 a sole carbon source (MSM+GLU); B) Agar Malt culture medium (MA); C) MSM plus 1% of CMC as a sole carbon source (MSM+CMC); D) MSM plus 1% of TCW as a sole carbon source (MSM+TCW).</a:t>
            </a:r>
            <a:r>
              <a:rPr lang="en-GB" sz="1000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sz="1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pic>
        <p:nvPicPr>
          <p:cNvPr id="20483" name="Picture 3"/>
          <p:cNvPicPr>
            <a:picLocks noChangeAspect="1" noChangeArrowheads="1"/>
          </p:cNvPicPr>
          <p:nvPr/>
        </p:nvPicPr>
        <p:blipFill>
          <a:blip r:embed="rId2" cstate="print"/>
          <a:srcRect r="13112"/>
          <a:stretch>
            <a:fillRect/>
          </a:stretch>
        </p:blipFill>
        <p:spPr bwMode="auto">
          <a:xfrm>
            <a:off x="1187624" y="1096822"/>
            <a:ext cx="6480720" cy="54285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539552" y="620688"/>
            <a:ext cx="8352928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000" b="1" dirty="0">
                <a:latin typeface="Times New Roman" pitchFamily="18" charset="0"/>
                <a:cs typeface="Times New Roman" pitchFamily="18" charset="0"/>
              </a:rPr>
              <a:t>Supplementary Fig. S2. </a:t>
            </a:r>
            <a:r>
              <a:rPr lang="en-GB" sz="1000" dirty="0">
                <a:latin typeface="Times New Roman" pitchFamily="18" charset="0"/>
                <a:cs typeface="Times New Roman" pitchFamily="18" charset="0"/>
              </a:rPr>
              <a:t>Effect of carbon source and light/darkness cycles on </a:t>
            </a:r>
            <a:r>
              <a:rPr lang="en-GB" sz="1000" i="1" dirty="0">
                <a:latin typeface="Times New Roman" pitchFamily="18" charset="0"/>
                <a:cs typeface="Times New Roman" pitchFamily="18" charset="0"/>
              </a:rPr>
              <a:t>B. cinerea </a:t>
            </a:r>
            <a:r>
              <a:rPr lang="en-GB" sz="1000" dirty="0">
                <a:latin typeface="Times New Roman" pitchFamily="18" charset="0"/>
                <a:cs typeface="Times New Roman" pitchFamily="18" charset="0"/>
              </a:rPr>
              <a:t>colony diameter.   Y-axis: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average size in mm of </a:t>
            </a:r>
            <a:r>
              <a:rPr lang="en-US" sz="1000" i="1" dirty="0">
                <a:latin typeface="Times New Roman" pitchFamily="18" charset="0"/>
                <a:cs typeface="Times New Roman" pitchFamily="18" charset="0"/>
              </a:rPr>
              <a:t>Botrytis cinerea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colony depending on the carbon source:</a:t>
            </a:r>
            <a:r>
              <a:rPr lang="en-GB" sz="1000" dirty="0">
                <a:latin typeface="Times New Roman" pitchFamily="18" charset="0"/>
                <a:cs typeface="Times New Roman" pitchFamily="18" charset="0"/>
              </a:rPr>
              <a:t> (1) MSM+1% glucose; (2) MSM+1% CMC; (3) MSM+1%  TCW; (4) MA. </a:t>
            </a:r>
            <a:r>
              <a:rPr lang="es-ES" sz="10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X-axis: light/ dark conditions:  (0) </a:t>
            </a:r>
            <a:r>
              <a:rPr lang="en-US" sz="1000" i="1" dirty="0">
                <a:latin typeface="Times New Roman" pitchFamily="18" charset="0"/>
                <a:cs typeface="Times New Roman" pitchFamily="18" charset="0"/>
              </a:rPr>
              <a:t>B. cinerea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culture in continuous darkness; (1 ) </a:t>
            </a:r>
            <a:r>
              <a:rPr lang="en-US" sz="1000" i="1" dirty="0">
                <a:latin typeface="Times New Roman" pitchFamily="18" charset="0"/>
                <a:cs typeface="Times New Roman" pitchFamily="18" charset="0"/>
              </a:rPr>
              <a:t>B. cinerea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culture in alternating 12h light/dark conditions. For each assayed medium, the influence of light/dark condition on the colony diameter is determined by the slope of the line joining the average colony diameter in  darkness ( 0)  with the  same value in light (1) . 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051720" y="1772816"/>
            <a:ext cx="5048250" cy="4457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323528" y="332656"/>
            <a:ext cx="828092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000" b="1" dirty="0">
                <a:latin typeface="Times New Roman" pitchFamily="18" charset="0"/>
                <a:cs typeface="Times New Roman" pitchFamily="18" charset="0"/>
              </a:rPr>
              <a:t>Supplementary Fig. S3. </a:t>
            </a:r>
            <a:r>
              <a:rPr lang="en-GB" sz="1000" dirty="0">
                <a:latin typeface="Times New Roman" pitchFamily="18" charset="0"/>
                <a:cs typeface="Times New Roman" pitchFamily="18" charset="0"/>
              </a:rPr>
              <a:t>Effect of carbon source and light/darkness condition on </a:t>
            </a:r>
            <a:r>
              <a:rPr lang="en-GB" sz="1000" i="1" dirty="0">
                <a:latin typeface="Times New Roman" pitchFamily="18" charset="0"/>
                <a:cs typeface="Times New Roman" pitchFamily="18" charset="0"/>
              </a:rPr>
              <a:t>B. cinerea</a:t>
            </a:r>
            <a:r>
              <a:rPr lang="en-GB" sz="1000" dirty="0">
                <a:latin typeface="Times New Roman" pitchFamily="18" charset="0"/>
                <a:cs typeface="Times New Roman" pitchFamily="18" charset="0"/>
              </a:rPr>
              <a:t> conidia production. Total</a:t>
            </a:r>
            <a:r>
              <a:rPr lang="en-GB" sz="10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000" dirty="0">
                <a:latin typeface="Times New Roman" pitchFamily="18" charset="0"/>
                <a:cs typeface="Times New Roman" pitchFamily="18" charset="0"/>
              </a:rPr>
              <a:t>conidia production of </a:t>
            </a:r>
            <a:r>
              <a:rPr lang="en-GB" sz="1000" i="1" dirty="0">
                <a:latin typeface="Times New Roman" pitchFamily="18" charset="0"/>
                <a:cs typeface="Times New Roman" pitchFamily="18" charset="0"/>
              </a:rPr>
              <a:t>B. cinerea </a:t>
            </a:r>
            <a:r>
              <a:rPr lang="en-GB" sz="1000" dirty="0">
                <a:latin typeface="Times New Roman" pitchFamily="18" charset="0"/>
                <a:cs typeface="Times New Roman" pitchFamily="18" charset="0"/>
              </a:rPr>
              <a:t>plotted against days post-inoculation (dpi) depending on light/darkness conditions and the available carbon source: (A) MA control; (B) GLU; (C) CMC; and (D) TCW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23863" y="1109811"/>
            <a:ext cx="8296275" cy="5343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9" name="Picture 1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04184" y="1772816"/>
            <a:ext cx="3024000" cy="3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1 Rectángulo">
            <a:extLst>
              <a:ext uri="{FF2B5EF4-FFF2-40B4-BE49-F238E27FC236}">
                <a16:creationId xmlns:a16="http://schemas.microsoft.com/office/drawing/2014/main" id="{5F116E83-3A3F-4F56-9E5C-684EA589F6A9}"/>
              </a:ext>
            </a:extLst>
          </p:cNvPr>
          <p:cNvSpPr/>
          <p:nvPr/>
        </p:nvSpPr>
        <p:spPr>
          <a:xfrm>
            <a:off x="323528" y="332656"/>
            <a:ext cx="8280920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000" b="1" dirty="0">
                <a:latin typeface="Times New Roman" pitchFamily="18" charset="0"/>
                <a:cs typeface="Times New Roman" pitchFamily="18" charset="0"/>
              </a:rPr>
              <a:t>Supplementary Fig. S4.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toxins production using Thin Layer Chromatography. Separation of organic compounds present in extracts from culture filtrate of 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GB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nerea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wn on different media. From left to right: (1) Highest purity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trydial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tern; (2) Highest purity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hydrobotrydial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tern; (3) Organic extract from culture filtrate of  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GB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nerea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zapeck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ox modified medium; 4) Organic extract from culture filtrate of 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GB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nerea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 Minimal Salt Medium  plus 1% of  TCW as  a sole carbon source; (5) Organic extract  from culture filtrate of 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GB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nerea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Minimal Salt Medium  plus 1% of  glucose as  a sole carbon source. 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6912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4"/>
          <p:cNvSpPr>
            <a:spLocks noChangeArrowheads="1"/>
          </p:cNvSpPr>
          <p:nvPr/>
        </p:nvSpPr>
        <p:spPr bwMode="auto">
          <a:xfrm>
            <a:off x="3911639" y="3324225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034" name="Rectangle 10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87624" y="1556792"/>
            <a:ext cx="6264000" cy="25842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1 Rectángulo">
            <a:extLst>
              <a:ext uri="{FF2B5EF4-FFF2-40B4-BE49-F238E27FC236}">
                <a16:creationId xmlns:a16="http://schemas.microsoft.com/office/drawing/2014/main" id="{91184F69-2EA5-4767-AD3D-AD27C639BC59}"/>
              </a:ext>
            </a:extLst>
          </p:cNvPr>
          <p:cNvSpPr/>
          <p:nvPr/>
        </p:nvSpPr>
        <p:spPr>
          <a:xfrm>
            <a:off x="323528" y="332656"/>
            <a:ext cx="828092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000" b="1" dirty="0">
                <a:latin typeface="Times New Roman" pitchFamily="18" charset="0"/>
                <a:cs typeface="Times New Roman" pitchFamily="18" charset="0"/>
              </a:rPr>
              <a:t>Supplementary Fig. S5. </a:t>
            </a:r>
            <a:r>
              <a:rPr lang="en-GB" sz="1000" dirty="0">
                <a:latin typeface="Times New Roman" pitchFamily="18" charset="0"/>
                <a:cs typeface="Times New Roman" pitchFamily="18" charset="0"/>
              </a:rPr>
              <a:t>NMR spectrum of (A) </a:t>
            </a:r>
            <a:r>
              <a:rPr lang="en-GB" sz="1000" dirty="0" err="1">
                <a:latin typeface="Times New Roman" pitchFamily="18" charset="0"/>
                <a:cs typeface="Times New Roman" pitchFamily="18" charset="0"/>
              </a:rPr>
              <a:t>Botrydial</a:t>
            </a:r>
            <a:r>
              <a:rPr lang="en-GB" sz="1000" dirty="0">
                <a:latin typeface="Times New Roman" pitchFamily="18" charset="0"/>
                <a:cs typeface="Times New Roman" pitchFamily="18" charset="0"/>
              </a:rPr>
              <a:t> and (B) </a:t>
            </a:r>
            <a:r>
              <a:rPr lang="en-GB" sz="1000" dirty="0" err="1">
                <a:latin typeface="Times New Roman" pitchFamily="18" charset="0"/>
                <a:cs typeface="Times New Roman" pitchFamily="18" charset="0"/>
              </a:rPr>
              <a:t>dihydrobotrydial</a:t>
            </a:r>
            <a:r>
              <a:rPr lang="en-GB" sz="1000" dirty="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53742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>
            <a:extLst>
              <a:ext uri="{FF2B5EF4-FFF2-40B4-BE49-F238E27FC236}">
                <a16:creationId xmlns:a16="http://schemas.microsoft.com/office/drawing/2014/main" id="{44CBF62D-3D2C-4023-8127-684EF7060817}"/>
              </a:ext>
            </a:extLst>
          </p:cNvPr>
          <p:cNvSpPr/>
          <p:nvPr/>
        </p:nvSpPr>
        <p:spPr>
          <a:xfrm>
            <a:off x="251520" y="332656"/>
            <a:ext cx="878497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. S6.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alysis of toxin production by UPLC-HRESIMS. Total ion current chromatograms (TIC) and extracted ion chromatograms (XIC) for glucose-based culture (GLU), </a:t>
            </a:r>
            <a:r>
              <a:rPr lang="en-GB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zapek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Dox culture (CZA) and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mato cell wall based culture (TCW).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XICs were obtained by selection of the corresponding mass for [M-H]</a:t>
            </a:r>
            <a:r>
              <a:rPr lang="en-GB" sz="10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on with a 0.006 </a:t>
            </a:r>
            <a:r>
              <a:rPr lang="en-GB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ma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ndow; m/z 309.170 for </a:t>
            </a:r>
            <a:r>
              <a:rPr lang="en-GB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trydial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chromatograms a1, b1 and c1) and 311.186 for </a:t>
            </a:r>
            <a:r>
              <a:rPr lang="en-GB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hydrobotrydial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chromatograms a2, b2 and c2). Ch</a:t>
            </a:r>
            <a:r>
              <a:rPr lang="en-US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omatograms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1 and b1 show an alignment of a peak in the time window between 1.35 and 1.50 min. for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 309.170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hich is not present, within that retention time window, in chromatogram c1.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h</a:t>
            </a:r>
            <a:r>
              <a:rPr lang="en-US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omatograms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2 and b2 show an alignment of a peak in the time window between 1.20 and 1.35 min. for </a:t>
            </a:r>
            <a:r>
              <a:rPr lang="en-GB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 311.186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hich is not present, within that retention time window, in chromatogram c1. Approximate retention time windows have been framed for clarity. </a:t>
            </a:r>
            <a:endParaRPr lang="es-ES" sz="1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FE56161-A012-4F6E-B19F-94CC0B00167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27584" y="1372795"/>
            <a:ext cx="7632848" cy="53047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220611854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611560" y="548681"/>
            <a:ext cx="7920880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itchFamily="18" charset="0"/>
              </a:rPr>
              <a:t>Supplementary Fig. S7. </a:t>
            </a:r>
            <a:r>
              <a:rPr lang="en-US" sz="1000" dirty="0">
                <a:latin typeface="Times New Roman" panose="02020603050405020304" pitchFamily="18" charset="0"/>
                <a:cs typeface="Times New Roman" pitchFamily="18" charset="0"/>
              </a:rPr>
              <a:t>Antimicrobial activity assay. The bactericidal activity of the organic extracts obtained was tested against 4 different bacteria: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tillis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 E. faecalis, P.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uorescens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ureus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y  the Agar diffusion test.  Organic extracts from filtrates of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cinerea,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ltured in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zapeck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x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dified media or in MSM plus TCW or Glucose as a sole carbon source, were dissolved in Ethyl acetate. Wafers (6 mm Ø) containing 1 mg of the organic extracts were placed at equidistant points over the bacterial lawn. As a control wafers containing only ethyl acetate were used. Plates were inoculated at 30ºC for 18 hours and then the diameter of the inhibition zone was observed . </a:t>
            </a:r>
            <a:endParaRPr lang="en-US" sz="1000" b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81100" y="1800225"/>
            <a:ext cx="6781800" cy="3257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8</TotalTime>
  <Words>1323</Words>
  <Application>Microsoft Office PowerPoint</Application>
  <PresentationFormat>Presentación en pantalla (4:3)</PresentationFormat>
  <Paragraphs>157</Paragraphs>
  <Slides>10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0</vt:i4>
      </vt:variant>
    </vt:vector>
  </HeadingPairs>
  <TitlesOfParts>
    <vt:vector size="15" baseType="lpstr">
      <vt:lpstr>Arial</vt:lpstr>
      <vt:lpstr>Calibri</vt:lpstr>
      <vt:lpstr>Times New Roman</vt:lpstr>
      <vt:lpstr>Wingdings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Eva LiRe</dc:creator>
  <cp:lastModifiedBy>Marisa ER</cp:lastModifiedBy>
  <cp:revision>33</cp:revision>
  <dcterms:created xsi:type="dcterms:W3CDTF">2015-04-13T18:36:43Z</dcterms:created>
  <dcterms:modified xsi:type="dcterms:W3CDTF">2017-10-30T00:04:50Z</dcterms:modified>
</cp:coreProperties>
</file>